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7" r:id="rId2"/>
  </p:sldIdLst>
  <p:sldSz cx="12192000" cy="6858000"/>
  <p:notesSz cx="6858000" cy="9144000"/>
  <p:defaultTextStyle>
    <a:defPPr>
      <a:defRPr lang="en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10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81ED58-08FF-0495-FF6F-D1FF2CEAFE8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7B6A2A2-543A-C300-4940-2D9EFCB629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D3B3AA-779A-D061-4E0A-66162E6C86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0B2C6-B704-46AC-971E-E006E52979F8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E850BD-C6A5-3957-5E1E-ACF1FB3B73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D6E10A-BF11-B438-0820-733D3429B8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76D6-A2F5-469A-BE0D-F68B1C00011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2463565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31DE58-D958-D4CB-8CA8-346C49A20D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BD04E1-9C96-ECA6-B5A9-91B42762EA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3FA1A6-BB7A-1474-B365-F1E8C458B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0B2C6-B704-46AC-971E-E006E52979F8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8263DD-828C-D6DD-B7C4-233DF11A96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FC8D2E-71AD-531A-AB29-67F2EA4E4F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76D6-A2F5-469A-BE0D-F68B1C00011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7225936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88D2420-D9FC-F4DA-FFAB-6F535B97C3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504D3E3-EF8B-D29B-87F7-DC75FD2749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E62DDE-9419-D709-F706-CD0AABB476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0B2C6-B704-46AC-971E-E006E52979F8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53974C-3497-2963-B7F1-0BD3A66098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D190B8-F06D-CC18-BE04-0CD569F0DA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76D6-A2F5-469A-BE0D-F68B1C00011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6669397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94A4D6-4A96-37ED-B36D-F3FD4C29DA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A228F5-3638-4C1B-F4CD-24BD6DE7F0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4E1443-4332-368A-AA58-6E31B94752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0B2C6-B704-46AC-971E-E006E52979F8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0DB649-96B5-EF0D-1631-E135D3457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011C67-16E8-C885-8C41-7326083C67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76D6-A2F5-469A-BE0D-F68B1C00011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5814527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7CE718-D45A-0B76-8B23-AB2658EEDC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B4CC8E-B155-7044-0440-B3319CB73F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30595A-3B08-0EF1-CBF9-147346EE1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0B2C6-B704-46AC-971E-E006E52979F8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8F0AE5-356B-21D3-4924-80AEF989A3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099F32-0764-CDD8-0578-F5F492AFA6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76D6-A2F5-469A-BE0D-F68B1C00011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137217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2AEC19-EE2B-9331-D389-DB8A9588C0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815A7F-3629-4AAA-AF72-0CB3D5F54B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191AD7-BEBA-9F95-A53D-28966E2BCF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971750-0771-A5E6-3DB8-F393C0074C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0B2C6-B704-46AC-971E-E006E52979F8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B80C0F-F4CF-06F9-3F27-6A94DCBF0F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0BA2BB-A85C-FB9F-6817-1DCA7E5B10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76D6-A2F5-469A-BE0D-F68B1C00011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039085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B7593A-C296-B184-EAD3-C77745D2B1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E976B3-B6FC-165B-C45F-C3EA8074E0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9F471C0-4EAA-78C8-2149-C94AA4B1D9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5D32156-3C60-00D9-1CB1-8E9AAE65B9D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37C40F5-22BF-EF68-7C92-B1B1017CB74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2F3E76B-F9ED-A634-DEAB-41DD6283E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0B2C6-B704-46AC-971E-E006E52979F8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0A8E154-77BF-05DF-DD5B-644A6D3EF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E978F53-7306-96B2-1F0B-FF973D98E1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76D6-A2F5-469A-BE0D-F68B1C00011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8033441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26708C-73C1-1623-9A7C-0B20F9A1EE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A1CC14A-EF81-2BDB-C33E-4E0AEF33C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0B2C6-B704-46AC-971E-E006E52979F8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2478F83-7118-25ED-659C-27D12CC8C3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B7FE1FF-78A0-E7C6-FAE2-166F59F65A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76D6-A2F5-469A-BE0D-F68B1C00011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192732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0836F2F-21FD-430E-CA23-0F2470547E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0B2C6-B704-46AC-971E-E006E52979F8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443E63B-917F-330F-554C-1A738BD93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BD291B6-5D62-0A51-7A3D-1D25D81058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76D6-A2F5-469A-BE0D-F68B1C00011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821409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055AB8-B9BE-D8E9-F2EF-440078ED5A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BC79EE-ED11-01C8-5A14-9B0878FF76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DC082C-7DF5-843C-6DA3-241752693F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F4E0D3-156E-A58A-7FEA-F944D96358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0B2C6-B704-46AC-971E-E006E52979F8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531545-105D-6B47-0A7B-C638A5AAF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923898-635F-FEAF-5A8D-2A725BA3CE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76D6-A2F5-469A-BE0D-F68B1C00011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2029556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E99828-EE4F-D683-E849-EA37C33283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D1DA720-E47B-8AED-D92B-FDCA547BB9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A3AA0AA-EE30-5A42-5695-FA155460FF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F28507-D93C-0E3D-D9EE-C66BD64997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0B2C6-B704-46AC-971E-E006E52979F8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EE3F1D-C253-CC28-89A3-6906BB3BDA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B85FC3-44CB-52FA-E1A4-8FABEF793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B76D6-A2F5-469A-BE0D-F68B1C00011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564115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B4D15AE-37D5-31DD-093B-4757E2D884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31C96C-A2F0-97CE-8ABB-F067C8D961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F0F56B-BE9F-8E46-ED64-B8E06F6815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4F0B2C6-B704-46AC-971E-E006E52979F8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BFCADB-EF39-12C4-048B-E497376F63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2980B9-4B90-0EAB-ABA3-3B860A2FD04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9B76D6-A2F5-469A-BE0D-F68B1C00011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629628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BDB3E460-3305-23D7-E532-18B8E968FBCF}"/>
              </a:ext>
            </a:extLst>
          </p:cNvPr>
          <p:cNvSpPr txBox="1"/>
          <p:nvPr/>
        </p:nvSpPr>
        <p:spPr>
          <a:xfrm>
            <a:off x="-8010" y="2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en-S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50994F2-B32C-7246-BA40-0883DA3FA678}"/>
              </a:ext>
            </a:extLst>
          </p:cNvPr>
          <p:cNvSpPr txBox="1"/>
          <p:nvPr/>
        </p:nvSpPr>
        <p:spPr>
          <a:xfrm>
            <a:off x="80106" y="30195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6D500D69-6885-A276-5F78-6EF1E861E93A}"/>
              </a:ext>
            </a:extLst>
          </p:cNvPr>
          <p:cNvGrpSpPr/>
          <p:nvPr/>
        </p:nvGrpSpPr>
        <p:grpSpPr>
          <a:xfrm>
            <a:off x="6561876" y="553999"/>
            <a:ext cx="2571340" cy="2680750"/>
            <a:chOff x="244296" y="440454"/>
            <a:chExt cx="2920325" cy="288122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F517801-9790-14F2-2EFE-82DC5D843F5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75375" y="440454"/>
              <a:ext cx="2789246" cy="2863958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66F6510-702A-22E8-9D4C-E0E5DFE8C9B6}"/>
                </a:ext>
              </a:extLst>
            </p:cNvPr>
            <p:cNvSpPr txBox="1"/>
            <p:nvPr/>
          </p:nvSpPr>
          <p:spPr>
            <a:xfrm rot="16200000">
              <a:off x="96959" y="1689979"/>
              <a:ext cx="556835" cy="26216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SE" sz="900" dirty="0">
                  <a:latin typeface="Arial" panose="020B0604020202020204" pitchFamily="34" charset="0"/>
                  <a:cs typeface="Arial" panose="020B0604020202020204" pitchFamily="34" charset="0"/>
                </a:rPr>
                <a:t>APNtg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AC76C62-49CF-674C-CD87-6DA7D47D8885}"/>
                </a:ext>
              </a:extLst>
            </p:cNvPr>
            <p:cNvSpPr txBox="1"/>
            <p:nvPr/>
          </p:nvSpPr>
          <p:spPr>
            <a:xfrm>
              <a:off x="1677398" y="3073580"/>
              <a:ext cx="413632" cy="24809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SE" sz="9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66EB592-052D-E86B-94B6-64EA50BBF48A}"/>
                </a:ext>
              </a:extLst>
            </p:cNvPr>
            <p:cNvSpPr txBox="1"/>
            <p:nvPr/>
          </p:nvSpPr>
          <p:spPr>
            <a:xfrm>
              <a:off x="944546" y="1849272"/>
              <a:ext cx="581125" cy="24809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SE" sz="900" dirty="0">
                  <a:latin typeface="Arial" panose="020B0604020202020204" pitchFamily="34" charset="0"/>
                  <a:cs typeface="Arial" panose="020B0604020202020204" pitchFamily="34" charset="0"/>
                </a:rPr>
                <a:t>AMPK</a:t>
              </a:r>
            </a:p>
          </p:txBody>
        </p:sp>
      </p:grpSp>
      <p:pic>
        <p:nvPicPr>
          <p:cNvPr id="10" name="Picture 9">
            <a:extLst>
              <a:ext uri="{FF2B5EF4-FFF2-40B4-BE49-F238E27FC236}">
                <a16:creationId xmlns:a16="http://schemas.microsoft.com/office/drawing/2014/main" id="{101CB88A-9A38-6EA3-B796-4290D9DCEDC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16267" r="12566" b="-1"/>
          <a:stretch/>
        </p:blipFill>
        <p:spPr>
          <a:xfrm>
            <a:off x="146627" y="626362"/>
            <a:ext cx="5579342" cy="496988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694090A-2AB2-0DD6-6473-0FA572C27FA7}"/>
              </a:ext>
            </a:extLst>
          </p:cNvPr>
          <p:cNvSpPr txBox="1"/>
          <p:nvPr/>
        </p:nvSpPr>
        <p:spPr>
          <a:xfrm>
            <a:off x="6522183" y="29760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FC12E97-A2D6-CC08-7EBD-4B293F189D2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92553" t="25810" b="66068"/>
          <a:stretch/>
        </p:blipFill>
        <p:spPr>
          <a:xfrm>
            <a:off x="5849242" y="626362"/>
            <a:ext cx="475187" cy="48204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0AF7408-A805-C3F7-559E-7C2B08EE2B90}"/>
              </a:ext>
            </a:extLst>
          </p:cNvPr>
          <p:cNvSpPr txBox="1"/>
          <p:nvPr/>
        </p:nvSpPr>
        <p:spPr>
          <a:xfrm rot="16200000">
            <a:off x="5292037" y="2213068"/>
            <a:ext cx="11144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000" dirty="0">
                <a:latin typeface="Arial" panose="020B0604020202020204" pitchFamily="34" charset="0"/>
                <a:cs typeface="Arial" panose="020B0604020202020204" pitchFamily="34" charset="0"/>
              </a:rPr>
              <a:t>Combined score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495F682-67D3-CD2C-E42A-647F11D73C80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85165" t="13604" r="8755" b="52638"/>
          <a:stretch/>
        </p:blipFill>
        <p:spPr>
          <a:xfrm>
            <a:off x="5916392" y="1261759"/>
            <a:ext cx="418214" cy="214884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1734E46-43BF-F0B8-4037-90A796AA814E}"/>
              </a:ext>
            </a:extLst>
          </p:cNvPr>
          <p:cNvSpPr txBox="1"/>
          <p:nvPr/>
        </p:nvSpPr>
        <p:spPr>
          <a:xfrm>
            <a:off x="203597" y="5473307"/>
            <a:ext cx="7701656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 S3.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) A clustered heat map of the combined kinase-substrate pairs for the top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hosphosites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all evaluated kinases in fetal liver. A higher combined score denotes a better fit to a kinase motif and kinase-substrate phosphorylation profile of a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hosphosite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Most kinases belong to the CMGC kinase group. B) Two-dimensional site-centric kinase activity analyses for comparisons of fetal livers from APNtg dams compared with wild type. The x- and y-axes denote the z-scores calculated for each kinase based on the overall changes of their substrates (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hosphosites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notated to each kinase based on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hosphoSitePlus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atabase) under each comparison</a:t>
            </a:r>
            <a:endParaRPr lang="en-S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21358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8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nisha Begum Samad</dc:creator>
  <cp:lastModifiedBy>Manisha Begum Samad</cp:lastModifiedBy>
  <cp:revision>1</cp:revision>
  <dcterms:created xsi:type="dcterms:W3CDTF">2025-03-18T10:00:39Z</dcterms:created>
  <dcterms:modified xsi:type="dcterms:W3CDTF">2025-03-18T10:01:31Z</dcterms:modified>
</cp:coreProperties>
</file>